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svg" ContentType="image/svg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</p:sldIdLst>
  <p:sldSz cx="9906000" cy="6858000" type="A4"/>
  <p:notesSz cx="6797675" cy="9926638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8B24406D-7252-48A2-8E61-5B47A0067A00}" v="20" dt="2023-03-22T11:25:13.204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86" d="100"/>
          <a:sy n="86" d="100"/>
        </p:scale>
        <p:origin x="1176" y="5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5/10/relationships/revisionInfo" Target="revisionInfo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84965C-83F5-4555-932A-BD684060A7EE}" type="datetimeFigureOut">
              <a:rPr lang="en-US" smtClean="0"/>
              <a:t>10/12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8F40E4-9DEC-401F-88B1-A53C44BD58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7986369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84965C-83F5-4555-932A-BD684060A7EE}" type="datetimeFigureOut">
              <a:rPr lang="en-US" smtClean="0"/>
              <a:t>10/12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8F40E4-9DEC-401F-88B1-A53C44BD58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046601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84965C-83F5-4555-932A-BD684060A7EE}" type="datetimeFigureOut">
              <a:rPr lang="en-US" smtClean="0"/>
              <a:t>10/12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8F40E4-9DEC-401F-88B1-A53C44BD58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5495906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84965C-83F5-4555-932A-BD684060A7EE}" type="datetimeFigureOut">
              <a:rPr lang="en-US" smtClean="0"/>
              <a:t>10/12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8F40E4-9DEC-401F-88B1-A53C44BD58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2594565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1709740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4589465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84965C-83F5-4555-932A-BD684060A7EE}" type="datetimeFigureOut">
              <a:rPr lang="en-US" smtClean="0"/>
              <a:t>10/12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8F40E4-9DEC-401F-88B1-A53C44BD58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1236697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84965C-83F5-4555-932A-BD684060A7EE}" type="datetimeFigureOut">
              <a:rPr lang="en-US" smtClean="0"/>
              <a:t>10/12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8F40E4-9DEC-401F-88B1-A53C44BD58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1344375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365127"/>
            <a:ext cx="8543925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1681163"/>
            <a:ext cx="419070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2505075"/>
            <a:ext cx="4190702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84965C-83F5-4555-932A-BD684060A7EE}" type="datetimeFigureOut">
              <a:rPr lang="en-US" smtClean="0"/>
              <a:t>10/12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8F40E4-9DEC-401F-88B1-A53C44BD58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502180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84965C-83F5-4555-932A-BD684060A7EE}" type="datetimeFigureOut">
              <a:rPr lang="en-US" smtClean="0"/>
              <a:t>10/12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8F40E4-9DEC-401F-88B1-A53C44BD58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4801887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84965C-83F5-4555-932A-BD684060A7EE}" type="datetimeFigureOut">
              <a:rPr lang="en-US" smtClean="0"/>
              <a:t>10/12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8F40E4-9DEC-401F-88B1-A53C44BD58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190220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987427"/>
            <a:ext cx="5014913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84965C-83F5-4555-932A-BD684060A7EE}" type="datetimeFigureOut">
              <a:rPr lang="en-US" smtClean="0"/>
              <a:t>10/12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8F40E4-9DEC-401F-88B1-A53C44BD58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1269863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987427"/>
            <a:ext cx="5014913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84965C-83F5-4555-932A-BD684060A7EE}" type="datetimeFigureOut">
              <a:rPr lang="en-US" smtClean="0"/>
              <a:t>10/12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8F40E4-9DEC-401F-88B1-A53C44BD58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1968346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184965C-83F5-4555-932A-BD684060A7EE}" type="datetimeFigureOut">
              <a:rPr lang="en-US" smtClean="0"/>
              <a:t>10/12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6356352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58F40E4-9DEC-401F-88B1-A53C44BD58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2525966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svg"/><Relationship Id="rId7" Type="http://schemas.openxmlformats.org/officeDocument/2006/relationships/image" Target="../media/image6.sv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sv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Graphic 2">
            <a:extLst>
              <a:ext uri="{FF2B5EF4-FFF2-40B4-BE49-F238E27FC236}">
                <a16:creationId xmlns:a16="http://schemas.microsoft.com/office/drawing/2014/main" id="{F88A5E4D-0287-F331-533B-8AE6F9A5A7F7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3"/>
              </a:ext>
            </a:extLst>
          </a:blip>
          <a:srcRect t="3689" r="16179"/>
          <a:stretch/>
        </p:blipFill>
        <p:spPr>
          <a:xfrm>
            <a:off x="237856" y="313765"/>
            <a:ext cx="3554216" cy="3467210"/>
          </a:xfrm>
          <a:prstGeom prst="rect">
            <a:avLst/>
          </a:prstGeom>
        </p:spPr>
      </p:pic>
      <p:pic>
        <p:nvPicPr>
          <p:cNvPr id="9" name="Graphic 8">
            <a:extLst>
              <a:ext uri="{FF2B5EF4-FFF2-40B4-BE49-F238E27FC236}">
                <a16:creationId xmlns:a16="http://schemas.microsoft.com/office/drawing/2014/main" id="{081B113A-E89A-CAA6-03D5-31D1C078C13A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5"/>
              </a:ext>
            </a:extLst>
          </a:blip>
          <a:srcRect t="7980" r="16877"/>
          <a:stretch/>
        </p:blipFill>
        <p:spPr>
          <a:xfrm>
            <a:off x="3792072" y="2274843"/>
            <a:ext cx="3740524" cy="1656340"/>
          </a:xfrm>
          <a:prstGeom prst="rect">
            <a:avLst/>
          </a:prstGeom>
        </p:spPr>
      </p:pic>
      <p:pic>
        <p:nvPicPr>
          <p:cNvPr id="10" name="Graphic 9">
            <a:extLst>
              <a:ext uri="{FF2B5EF4-FFF2-40B4-BE49-F238E27FC236}">
                <a16:creationId xmlns:a16="http://schemas.microsoft.com/office/drawing/2014/main" id="{FD370D09-AB9C-613A-D99C-0CA881B329EA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5"/>
              </a:ext>
            </a:extLst>
          </a:blip>
          <a:srcRect l="83764" t="10845" b="8472"/>
          <a:stretch/>
        </p:blipFill>
        <p:spPr>
          <a:xfrm>
            <a:off x="7646894" y="1147482"/>
            <a:ext cx="730609" cy="1452284"/>
          </a:xfrm>
          <a:prstGeom prst="rect">
            <a:avLst/>
          </a:prstGeom>
        </p:spPr>
      </p:pic>
      <p:pic>
        <p:nvPicPr>
          <p:cNvPr id="14" name="Graphic 13">
            <a:extLst>
              <a:ext uri="{FF2B5EF4-FFF2-40B4-BE49-F238E27FC236}">
                <a16:creationId xmlns:a16="http://schemas.microsoft.com/office/drawing/2014/main" id="{319D52CF-6CF3-F7D6-3D09-B2720F7C8726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7"/>
              </a:ext>
            </a:extLst>
          </a:blip>
          <a:srcRect t="7751" r="16155"/>
          <a:stretch/>
        </p:blipFill>
        <p:spPr>
          <a:xfrm>
            <a:off x="3881719" y="333601"/>
            <a:ext cx="3675528" cy="1815734"/>
          </a:xfrm>
          <a:prstGeom prst="rect">
            <a:avLst/>
          </a:prstGeom>
        </p:spPr>
      </p:pic>
      <p:sp>
        <p:nvSpPr>
          <p:cNvPr id="15" name="TextBox 14">
            <a:extLst>
              <a:ext uri="{FF2B5EF4-FFF2-40B4-BE49-F238E27FC236}">
                <a16:creationId xmlns:a16="http://schemas.microsoft.com/office/drawing/2014/main" id="{799F1F36-17B1-6796-66FE-8E77F23BD2A3}"/>
              </a:ext>
            </a:extLst>
          </p:cNvPr>
          <p:cNvSpPr txBox="1"/>
          <p:nvPr/>
        </p:nvSpPr>
        <p:spPr>
          <a:xfrm>
            <a:off x="6211402" y="80264"/>
            <a:ext cx="53251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BO/O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AB14C1B2-FBE3-70C6-0018-FD9962953276}"/>
              </a:ext>
            </a:extLst>
          </p:cNvPr>
          <p:cNvSpPr txBox="1"/>
          <p:nvPr/>
        </p:nvSpPr>
        <p:spPr>
          <a:xfrm>
            <a:off x="2486820" y="93094"/>
            <a:ext cx="49404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BL/O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970F0DD0-5BF7-2001-B556-FC00E681CFF3}"/>
              </a:ext>
            </a:extLst>
          </p:cNvPr>
          <p:cNvSpPr txBox="1"/>
          <p:nvPr/>
        </p:nvSpPr>
        <p:spPr>
          <a:xfrm>
            <a:off x="5991553" y="2058587"/>
            <a:ext cx="73060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BL/BO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0F8C64F5-958D-CFAF-0C83-6DFF20D0F5FC}"/>
              </a:ext>
            </a:extLst>
          </p:cNvPr>
          <p:cNvSpPr txBox="1"/>
          <p:nvPr/>
        </p:nvSpPr>
        <p:spPr>
          <a:xfrm>
            <a:off x="0" y="267631"/>
            <a:ext cx="26642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A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1FC651A2-CDD6-4F3F-DBE1-208A78B69012}"/>
              </a:ext>
            </a:extLst>
          </p:cNvPr>
          <p:cNvSpPr txBox="1"/>
          <p:nvPr/>
        </p:nvSpPr>
        <p:spPr>
          <a:xfrm>
            <a:off x="3748509" y="267631"/>
            <a:ext cx="26642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B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FA6522CB-8DD0-269C-D405-D44AFA5C63F2}"/>
              </a:ext>
            </a:extLst>
          </p:cNvPr>
          <p:cNvSpPr txBox="1"/>
          <p:nvPr/>
        </p:nvSpPr>
        <p:spPr>
          <a:xfrm>
            <a:off x="3769920" y="2126726"/>
            <a:ext cx="26000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C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5020345B-E63F-CB6D-40AB-FB62ABAC88F6}"/>
              </a:ext>
            </a:extLst>
          </p:cNvPr>
          <p:cNvSpPr txBox="1"/>
          <p:nvPr/>
        </p:nvSpPr>
        <p:spPr>
          <a:xfrm>
            <a:off x="150742" y="3961451"/>
            <a:ext cx="9604515" cy="58477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600" b="1" dirty="0"/>
              <a:t>Supplementary Figure </a:t>
            </a:r>
            <a:r>
              <a:rPr lang="en-GB" sz="1600" b="1" dirty="0"/>
              <a:t>S3</a:t>
            </a:r>
            <a:r>
              <a:rPr lang="en-US" sz="1600" b="1" dirty="0"/>
              <a:t>. </a:t>
            </a:r>
            <a:r>
              <a:rPr lang="en-US" sz="1600" dirty="0"/>
              <a:t>Bubble plot for </a:t>
            </a:r>
            <a:r>
              <a:rPr lang="pl-PL" sz="1600" dirty="0"/>
              <a:t>Kyoto Encyclopedia of </a:t>
            </a:r>
            <a:r>
              <a:rPr lang="pl-PL" sz="1600" dirty="0" err="1"/>
              <a:t>Genes</a:t>
            </a:r>
            <a:r>
              <a:rPr lang="pl-PL" sz="1600" dirty="0"/>
              <a:t> and </a:t>
            </a:r>
            <a:r>
              <a:rPr lang="pl-PL" sz="1600" dirty="0" err="1"/>
              <a:t>Genomes</a:t>
            </a:r>
            <a:r>
              <a:rPr lang="pl-PL" sz="1600" dirty="0"/>
              <a:t> (</a:t>
            </a:r>
            <a:r>
              <a:rPr lang="pl-PL" sz="1600" dirty="0" err="1"/>
              <a:t>KEGG</a:t>
            </a:r>
            <a:r>
              <a:rPr lang="pl-PL" sz="1600" dirty="0"/>
              <a:t>) </a:t>
            </a:r>
            <a:r>
              <a:rPr lang="pl-PL" sz="1600" dirty="0" err="1"/>
              <a:t>pathways</a:t>
            </a:r>
            <a:r>
              <a:rPr lang="pl-PL" sz="1600" dirty="0"/>
              <a:t> </a:t>
            </a:r>
            <a:r>
              <a:rPr lang="en-US" sz="1600" dirty="0"/>
              <a:t>enrichment analysis in black vs. control (A), middle vs. control (B), and black vs. middle (C) comparisons. </a:t>
            </a:r>
          </a:p>
        </p:txBody>
      </p:sp>
    </p:spTree>
    <p:extLst>
      <p:ext uri="{BB962C8B-B14F-4D97-AF65-F5344CB8AC3E}">
        <p14:creationId xmlns:p14="http://schemas.microsoft.com/office/powerpoint/2010/main" val="112615109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73</TotalTime>
  <Words>56</Words>
  <Application>Microsoft Office PowerPoint</Application>
  <PresentationFormat>A4 Paper (210x297 mm)</PresentationFormat>
  <Paragraphs>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Gabriela Machaj</dc:creator>
  <cp:lastModifiedBy>Kristin Xie</cp:lastModifiedBy>
  <cp:revision>8</cp:revision>
  <cp:lastPrinted>2023-03-24T09:10:18Z</cp:lastPrinted>
  <dcterms:created xsi:type="dcterms:W3CDTF">2023-03-20T09:37:55Z</dcterms:created>
  <dcterms:modified xsi:type="dcterms:W3CDTF">2023-10-12T07:30:28Z</dcterms:modified>
</cp:coreProperties>
</file>